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886" autoAdjust="0"/>
    <p:restoredTop sz="92276" autoAdjust="0"/>
  </p:normalViewPr>
  <p:slideViewPr>
    <p:cSldViewPr snapToGrid="0">
      <p:cViewPr varScale="1">
        <p:scale>
          <a:sx n="89" d="100"/>
          <a:sy n="89" d="100"/>
        </p:scale>
        <p:origin x="110" y="245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26" d="100"/>
        <a:sy n="12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EB08D0-07D1-4FCA-9739-7285C6712C70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540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73575"/>
            <a:ext cx="55054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A335A4-D22F-4220-A92B-B9BF61066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893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3511E5-3772-40AB-872A-1A89D3A39A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1C81B7-40B7-4F8F-8BD0-0AA15256CA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7E7419-88CE-4A8D-AFE8-64D41CC9B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F2CE16-9BC8-4F91-A3A5-C1DD495FC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408440-F70F-4D83-B488-EA19E1705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13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9AAB0E-873E-4A72-8996-58325FD295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84F6C1-A7B2-4F5D-B642-FF6BF5A7CD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0FE7D9-E22E-40D9-993D-89DA005C0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05492E-C4F2-4A52-B644-48E44E0B8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18BC3-CA0C-4E54-A556-19EAF8C07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685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AEAE64-A6C8-4496-B54A-0785F62D7B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78FC39-6C3F-44A5-B707-7AF18D7805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27312E-C61F-4974-AC58-487210C60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8EFAC5-EB6C-4B2C-A45E-6D093B33E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E8DE9B-562E-493C-ABCF-5F33F6BAB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993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0A352-C5FD-4EFE-944E-2EB093206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F1879A-DFDB-4275-BE41-8E9D400804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18339-6E36-40A4-94EA-70E46566B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4C7E52-CD83-405B-B1B9-56EB7ADFB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61D67-D46A-4FA5-85DE-272A2736F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227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2B63FA-BF7E-48D1-A473-6813401A9A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392FB2-870A-44CB-A263-B50CFE5C6B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8D5B81-FC1C-49D2-8295-90E2A329D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79BDA-BF16-49F2-B87C-E36F090F5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82DAC-DC66-433B-9DF7-2C7D3D835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3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D86169-166F-4272-BF78-44F83EBFAC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8BD9F8-A684-47DB-BA93-37355A8B21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22F5B8-3ECF-4E9D-92B4-C8D86B407E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691DE8-EAA4-46E3-B2C6-94F3ECC8A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4C53AC-C969-412C-BCC5-60D911105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858094-6D92-4652-AE06-589C26D9E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729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5B880-588A-4020-B8FE-0B62388C8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3593CD-AA23-4D95-85E6-DA886FBB37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5D0097-71EC-4C6F-996B-F373F47939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94B055-36A4-409B-AE1D-E840E947F1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B0C06F-5F5C-4E04-98E7-E503EE9C01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72348E-D15A-4805-AC59-DF380BD0D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7D6FEA-50CF-461C-8DAA-13108FBD7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7D9578-86FE-4605-9AA9-2F25DF681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154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B75220-FA78-49F8-BB7E-88DBFAE92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8F14FE-9F66-4406-BDC9-8A24E54F7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5DB50D-4A3A-48F4-8168-6FA75F7D9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F240E0-E715-4EAB-BA52-D62CB52FB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666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029A0-4C99-4F26-9F6D-7E523132D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6A45C0-9E4A-4417-A8EB-A3F4D80FC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A12FE3-DF8E-4408-8DC5-D4E58F820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678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16730-0810-45BC-81DE-3E112FE3A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66836C-D5F3-4E66-AE6E-4BF6071335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A0F478-6AAE-40CD-B4C3-1A03642956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BB5C71-72D8-450D-9106-6D100C370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44DE36-FE5D-4DE2-B856-34296EA59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FFF802-6D2D-4874-8996-AED6F7255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33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8A712C-AABD-4E9C-AA78-64FCF0944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9F6720-053A-485B-9A96-670F80CA4C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3B7C13-84FE-4D57-9B51-EF0815E411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374A54-1B62-4720-BBDB-31B480768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F09770-65EF-429F-A76D-A65AD7860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A9DE4E-B379-4424-BED9-8B11ED688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566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E35207-D1FB-45E2-B788-63E502F344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502CA1-5EF6-4DDB-B55E-AF27B8C416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0CF55-47F0-4018-9AE4-B77803D66A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37B262-F7E5-4BE1-A642-7AC135EE39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A93D6C-2A45-4028-85C3-E7D94264AF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49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7C24F37-1C6F-4754-B666-FB732C3622A4}"/>
              </a:ext>
            </a:extLst>
          </p:cNvPr>
          <p:cNvGrpSpPr/>
          <p:nvPr/>
        </p:nvGrpSpPr>
        <p:grpSpPr>
          <a:xfrm>
            <a:off x="998243" y="875177"/>
            <a:ext cx="9690538" cy="4151589"/>
            <a:chOff x="-3417014" y="3381894"/>
            <a:chExt cx="10303709" cy="3127865"/>
          </a:xfrm>
          <a:solidFill>
            <a:schemeClr val="tx1"/>
          </a:solidFill>
        </p:grpSpPr>
        <p:pic>
          <p:nvPicPr>
            <p:cNvPr id="8" name="Picture 7" descr="Chart&#10;&#10;Description automatically generated">
              <a:extLst>
                <a:ext uri="{FF2B5EF4-FFF2-40B4-BE49-F238E27FC236}">
                  <a16:creationId xmlns:a16="http://schemas.microsoft.com/office/drawing/2014/main" id="{B4E0F9A5-0CC7-44D5-865C-065F2FD19A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t="420"/>
            <a:stretch/>
          </p:blipFill>
          <p:spPr>
            <a:xfrm>
              <a:off x="-3417014" y="3381895"/>
              <a:ext cx="6255405" cy="3127864"/>
            </a:xfrm>
            <a:prstGeom prst="rect">
              <a:avLst/>
            </a:prstGeom>
            <a:grpFill/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4534DA8-EB3F-46E0-ADB6-D6AACCDC32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duotone>
                <a:prstClr val="black"/>
                <a:srgbClr val="FFC000">
                  <a:tint val="45000"/>
                  <a:satMod val="400000"/>
                </a:srgbClr>
              </a:duotone>
              <a:alphaModFix amt="79000"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colorTemperature colorTemp="11200"/>
                      </a14:imgEffect>
                      <a14:imgEffect>
                        <a14:saturation sat="98000"/>
                      </a14:imgEffect>
                      <a14:imgEffect>
                        <a14:brightnessContrast bright="15000" contrast="-10000"/>
                      </a14:imgEffect>
                    </a14:imgLayer>
                  </a14:imgProps>
                </a:ext>
              </a:extLst>
            </a:blip>
            <a:srcRect t="20201"/>
            <a:stretch/>
          </p:blipFill>
          <p:spPr>
            <a:xfrm>
              <a:off x="3030114" y="3381894"/>
              <a:ext cx="3856581" cy="2892763"/>
            </a:xfrm>
            <a:prstGeom prst="rect">
              <a:avLst/>
            </a:prstGeom>
            <a:grpFill/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1001FD63-25AA-43B1-B87D-3C09FCC09A14}"/>
              </a:ext>
            </a:extLst>
          </p:cNvPr>
          <p:cNvSpPr txBox="1"/>
          <p:nvPr/>
        </p:nvSpPr>
        <p:spPr>
          <a:xfrm>
            <a:off x="8281648" y="576203"/>
            <a:ext cx="1566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lot Statistic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EB1AF22-871C-3B98-11BF-0AD823B488CB}"/>
              </a:ext>
            </a:extLst>
          </p:cNvPr>
          <p:cNvSpPr txBox="1"/>
          <p:nvPr/>
        </p:nvSpPr>
        <p:spPr>
          <a:xfrm>
            <a:off x="345688" y="5257414"/>
            <a:ext cx="1110661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amachandran plot of DiMT protein by PROCHECK server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ting colors represent phi-psi backbone conformational areas: red represents the most favored regions, brown and yellow represent additional and generously allowed regions, while light-yellow patches represent regions that are not allowed. 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sky-blue dots represent (φ, ψ) angles for each residue of the predicted structure.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helical (around 0, -45° and -75°, -45°) and β-sheet (near 135° and 180°) regions are highlighted with red color. 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jority of the blue dots amino acid residues lie within th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β-sheet  and 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right-hand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lix regions. 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Ramachandran plot statistics reveal that 92.7% of residues lie within the most favored region, indicating the reliability of the predicted model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DD74AEB-A8D0-6281-1463-2D707B57B5E2}"/>
              </a:ext>
            </a:extLst>
          </p:cNvPr>
          <p:cNvSpPr txBox="1"/>
          <p:nvPr/>
        </p:nvSpPr>
        <p:spPr>
          <a:xfrm>
            <a:off x="1579419" y="505845"/>
            <a:ext cx="31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5AB0B69-1791-7760-DCCB-B39A568B78F6}"/>
              </a:ext>
            </a:extLst>
          </p:cNvPr>
          <p:cNvSpPr txBox="1"/>
          <p:nvPr/>
        </p:nvSpPr>
        <p:spPr>
          <a:xfrm>
            <a:off x="6988261" y="505845"/>
            <a:ext cx="31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851906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1</TotalTime>
  <Words>12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a, Mukthar</dc:creator>
  <cp:lastModifiedBy>Witola, William Harold</cp:lastModifiedBy>
  <cp:revision>205</cp:revision>
  <cp:lastPrinted>2024-01-22T18:41:37Z</cp:lastPrinted>
  <dcterms:created xsi:type="dcterms:W3CDTF">2024-01-18T19:24:34Z</dcterms:created>
  <dcterms:modified xsi:type="dcterms:W3CDTF">2024-08-22T01:43:13Z</dcterms:modified>
</cp:coreProperties>
</file>